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  <p:sldId id="273" r:id="rId3"/>
    <p:sldId id="263" r:id="rId4"/>
    <p:sldId id="264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76BF3"/>
    <a:srgbClr val="00B0F6"/>
    <a:srgbClr val="00BF7D"/>
    <a:srgbClr val="A3A500"/>
    <a:srgbClr val="F8766D"/>
    <a:srgbClr val="E41A1C"/>
    <a:srgbClr val="377EB8"/>
    <a:srgbClr val="4DAF4A"/>
    <a:srgbClr val="984EA3"/>
    <a:srgbClr val="FF7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7" d="100"/>
          <a:sy n="67" d="100"/>
        </p:scale>
        <p:origin x="60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808058-F4CF-4925-9E87-AE4272F7201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3CAF05F-F963-455F-8BEB-D824E0D70E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CF0CD6-D7BD-46AB-9157-B5A498113A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96220C-7094-4751-B571-5D750322C54C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34B499-FB07-41EC-80A0-B4E50ABB5E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7A76C1-A340-4385-BC9C-3FA228E9AB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27902-2E0B-4897-9041-34C965660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61281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47E673-A677-46DA-9C18-B80D07EDBE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1A0C0D5-D026-4045-B947-FF8556CF71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D49866-A0F0-4591-A17D-37BA74B59E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96220C-7094-4751-B571-5D750322C54C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6BD329-2301-450F-A03E-988C5BB5B5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2E0DFF-9891-4639-828D-01C4D7086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27902-2E0B-4897-9041-34C965660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46755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661674A-6B88-4CCB-8F47-B328CBB79EE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F2059E-0566-4505-A45A-362759BAC3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91B21D-B031-4C4E-9E3E-442F5748EC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96220C-7094-4751-B571-5D750322C54C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CC28A7-BEB1-4696-8764-3DB5F4F050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DD01FD-D3E9-4032-B9F8-F3AF40660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27902-2E0B-4897-9041-34C965660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17017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A253AC-E112-4924-8B5D-A16B9DC594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A924EB-423D-4E12-8B6B-39C9514315C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414393-1997-45DD-88FB-FC88563DA5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96220C-7094-4751-B571-5D750322C54C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B691FB-0D83-46CF-B992-D0E2BB6B87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9E9636-8242-4351-885C-1CBDFBF3D2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27902-2E0B-4897-9041-34C965660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4587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A317DC-9CA7-4713-B929-CE52B698CE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DCA540-B353-438D-9FFF-859CC8A2AD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41BBC2-48D2-4ED3-802B-A3379CA3C8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96220C-7094-4751-B571-5D750322C54C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18EC21-3B7A-4922-B73C-C4B24731F8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5828D4-F0E6-42AE-8200-D6EE3B052C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27902-2E0B-4897-9041-34C965660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47569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BA790B-1C88-4CF5-B58F-4D7124E2F4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31A8BF-992D-4E57-AB20-21D5E928B9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63FC392-40B1-4505-979B-CD396142BD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009828-CBDE-4AD9-954F-E31C9AC5B1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96220C-7094-4751-B571-5D750322C54C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77A2D6-4B7F-48EF-93F3-18CE53C6C7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A223BD-ADB7-4CFC-8D14-FFC49A1655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27902-2E0B-4897-9041-34C965660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178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489486-AF76-4B85-9EE6-15D5FCB221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46CBAE-AD0D-4BD9-8B4D-3D5DA46AE9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C48B418-DB42-4B5D-8D12-10D56F95EC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49BF3D8-28FB-4B57-A358-3ED1B3C90B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25B71EC-651F-482E-A5A6-68FF0AE7FB1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CD85764-2D98-48E0-84B3-4CC5DC16AF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96220C-7094-4751-B571-5D750322C54C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35D0E98-07B7-400B-B450-E9752BEBF1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8946BA1-1871-4437-A1FD-558811F1E4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27902-2E0B-4897-9041-34C965660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45637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D2BC8D-7285-44E2-825A-D282CC0AD8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9A7206A-47EF-4D42-A835-029FA43046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96220C-7094-4751-B571-5D750322C54C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6A37D82-7D86-4F13-A7FA-2E5038907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FFD7D88-B976-40BE-9DA9-12F549799B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27902-2E0B-4897-9041-34C965660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44434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516C526-8695-48C9-A272-DB7A9392A0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96220C-7094-4751-B571-5D750322C54C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4BFE283-F949-4D10-AD5B-42FF45CE02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C195B10-DE0B-4137-8CCC-B7D34BC6A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27902-2E0B-4897-9041-34C965660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2782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1495BC-A32E-41E1-8606-1EFC5A2F7A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157121-CD27-4728-B8FE-C9B9CAF75A0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D433F49-ADAE-49F1-A87B-0A3B2E095D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D97A39-DFFA-48D5-8251-51D5329025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96220C-7094-4751-B571-5D750322C54C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C3550C-4F13-4755-94CA-5A1A816E5D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15B2947-BA0A-4A59-8F31-7BD01898FF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27902-2E0B-4897-9041-34C965660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20559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DBFBDE-57FB-4AE8-8F6E-5F190AAC3D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03DC02A-2685-4AFC-9CCD-ACC52D6B171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83D9868-03DB-4976-8E72-F2306A2DAC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BFB78F-A541-418E-874F-816CE3428B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96220C-7094-4751-B571-5D750322C54C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4E1A62-3A9A-48D6-ABBC-9642F6D133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6249E6-A5CE-4A2D-B2B1-97C28DC7A3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27902-2E0B-4897-9041-34C965660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04534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5874717-4101-41C5-AA42-A363F8CDA5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2C0561-B0E6-4521-B22F-3CEF502E73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22D4F8-4DDF-405A-8591-DFC7606ADC0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96220C-7094-4751-B571-5D750322C54C}" type="datetimeFigureOut">
              <a:rPr lang="en-GB" smtClean="0"/>
              <a:t>08/04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65F782-C498-413E-8A2C-02F2B176694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356C1B-9818-46A3-B14F-1055C079FF3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327902-2E0B-4897-9041-34C965660D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19749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A screenshot of a computer&#10;&#10;Description automatically generated with low confidence">
            <a:extLst>
              <a:ext uri="{FF2B5EF4-FFF2-40B4-BE49-F238E27FC236}">
                <a16:creationId xmlns:a16="http://schemas.microsoft.com/office/drawing/2014/main" id="{C0D3509B-3D2C-4976-BC71-92D00588D16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1569" y="392126"/>
            <a:ext cx="5296306" cy="563680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A4A5F42-67C0-4031-9D94-8D673AC558A7}"/>
              </a:ext>
            </a:extLst>
          </p:cNvPr>
          <p:cNvSpPr txBox="1"/>
          <p:nvPr/>
        </p:nvSpPr>
        <p:spPr>
          <a:xfrm>
            <a:off x="6191250" y="1119073"/>
            <a:ext cx="5296306" cy="46198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>
              <a:lnSpc>
                <a:spcPct val="150000"/>
              </a:lnSpc>
            </a:pPr>
            <a:r>
              <a:rPr lang="en-US" sz="18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Fig S1. </a:t>
            </a:r>
            <a:r>
              <a:rPr lang="en-US" sz="18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Schematic representation of biosynthetic pathways for endogenous fatty acid biosynthesis (grey box) and also non-native transgene-derived modifications. These were as follows:  </a:t>
            </a:r>
            <a:r>
              <a:rPr lang="el-GR" sz="18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Δ</a:t>
            </a:r>
            <a:r>
              <a:rPr lang="en-US" sz="18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6 Des = </a:t>
            </a:r>
            <a:r>
              <a:rPr lang="el-GR" sz="18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Δ</a:t>
            </a:r>
            <a:r>
              <a:rPr lang="en-US" sz="18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6-desaturase; </a:t>
            </a:r>
            <a:r>
              <a:rPr lang="en-US" sz="1800" dirty="0">
                <a:effectLst/>
                <a:latin typeface="Symbol" panose="05050102010706020507" pitchFamily="18" charset="2"/>
                <a:ea typeface="SimSun" panose="02010600030101010101" pitchFamily="2" charset="-122"/>
                <a:cs typeface="Calibri" panose="020F0502020204030204" pitchFamily="34" charset="0"/>
              </a:rPr>
              <a:t>D</a:t>
            </a:r>
            <a:r>
              <a:rPr lang="en-US" sz="18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6 Elo =</a:t>
            </a:r>
            <a:r>
              <a:rPr lang="en-US" sz="18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 </a:t>
            </a:r>
            <a:r>
              <a:rPr lang="el-GR" sz="18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Δ</a:t>
            </a:r>
            <a:r>
              <a:rPr lang="en-US" sz="18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6-elongase; </a:t>
            </a:r>
            <a:r>
              <a:rPr lang="en-US" sz="1800" dirty="0">
                <a:effectLst/>
                <a:latin typeface="Symbol" panose="05050102010706020507" pitchFamily="18" charset="2"/>
                <a:ea typeface="SimSun" panose="02010600030101010101" pitchFamily="2" charset="-122"/>
                <a:cs typeface="Calibri" panose="020F0502020204030204" pitchFamily="34" charset="0"/>
              </a:rPr>
              <a:t>D</a:t>
            </a:r>
            <a:r>
              <a:rPr lang="en-US" sz="18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5 Des = </a:t>
            </a:r>
            <a:r>
              <a:rPr lang="el-GR" sz="18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Δ</a:t>
            </a:r>
            <a:r>
              <a:rPr lang="en-US" sz="18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5-desaturase;  </a:t>
            </a:r>
            <a:r>
              <a:rPr lang="en-US" sz="1800" dirty="0">
                <a:effectLst/>
                <a:latin typeface="Symbol" panose="05050102010706020507" pitchFamily="18" charset="2"/>
                <a:ea typeface="SimSun" panose="02010600030101010101" pitchFamily="2" charset="-122"/>
                <a:cs typeface="Calibri" panose="020F0502020204030204" pitchFamily="34" charset="0"/>
              </a:rPr>
              <a:t>D</a:t>
            </a:r>
            <a:r>
              <a:rPr lang="en-US" sz="18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12 Des =</a:t>
            </a:r>
            <a:r>
              <a:rPr lang="el-GR" sz="18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 Δ</a:t>
            </a:r>
            <a:r>
              <a:rPr lang="en-US" sz="18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12-desaturase; w3 Des = w3-desaturase; </a:t>
            </a:r>
            <a:r>
              <a:rPr lang="en-US" sz="1800" dirty="0">
                <a:effectLst/>
                <a:latin typeface="Symbol" panose="05050102010706020507" pitchFamily="18" charset="2"/>
                <a:ea typeface="SimSun" panose="02010600030101010101" pitchFamily="2" charset="-122"/>
                <a:cs typeface="Calibri" panose="020F0502020204030204" pitchFamily="34" charset="0"/>
              </a:rPr>
              <a:t>D</a:t>
            </a:r>
            <a:r>
              <a:rPr lang="en-US" sz="18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5 Elo =  </a:t>
            </a:r>
            <a:r>
              <a:rPr lang="el-GR" sz="18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Δ</a:t>
            </a:r>
            <a:r>
              <a:rPr lang="en-US" sz="18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5-elongase; </a:t>
            </a:r>
            <a:r>
              <a:rPr lang="en-US" sz="1800" dirty="0">
                <a:effectLst/>
                <a:latin typeface="Symbol" panose="05050102010706020507" pitchFamily="18" charset="2"/>
                <a:ea typeface="SimSun" panose="02010600030101010101" pitchFamily="2" charset="-122"/>
                <a:cs typeface="Calibri" panose="020F0502020204030204" pitchFamily="34" charset="0"/>
              </a:rPr>
              <a:t>D</a:t>
            </a:r>
            <a:r>
              <a:rPr lang="en-US" sz="18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4 Des = </a:t>
            </a:r>
            <a:r>
              <a:rPr lang="el-GR" sz="18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Δ4-</a:t>
            </a:r>
            <a:r>
              <a:rPr lang="en-US" sz="18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desaturase. Fatty acids and their common abbreviations are shown.  The pathway blocked as a consequence of CRISPR-Cas9-mediated inactivation of FAE1 is indicated with a red </a:t>
            </a:r>
            <a:r>
              <a:rPr lang="en-US" sz="18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X</a:t>
            </a:r>
            <a:endParaRPr lang="en-GB" sz="1800" b="1" dirty="0">
              <a:solidFill>
                <a:srgbClr val="FF0000"/>
              </a:solidFill>
              <a:effectLst/>
              <a:latin typeface="Calibri" panose="020F0502020204030204" pitchFamily="34" charset="0"/>
              <a:ea typeface="SimSun" panose="02010600030101010101" pitchFamily="2" charset="-122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40425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8E16E26-9E3F-4489-91CB-620FFE7ABF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7284" y="1052593"/>
            <a:ext cx="11036125" cy="80478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432E645-1FDC-48BF-BAB5-24EEAF718A74}"/>
              </a:ext>
            </a:extLst>
          </p:cNvPr>
          <p:cNvSpPr txBox="1"/>
          <p:nvPr/>
        </p:nvSpPr>
        <p:spPr>
          <a:xfrm>
            <a:off x="1352550" y="2362200"/>
            <a:ext cx="9486900" cy="38779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>
              <a:lnSpc>
                <a:spcPct val="200000"/>
              </a:lnSpc>
            </a:pPr>
            <a:r>
              <a:rPr lang="en-US" sz="18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Fig S2.  </a:t>
            </a:r>
            <a:r>
              <a:rPr lang="en-US" sz="12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Schematic representation of the DHA2015.1 construct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. The different DNA parts (promoters, genes, 3’UTR+terminators,  T-DNA borders) are illustrated by symbols. Different enzyme activities in Figure 1a encoded by synthetic genes under the control of seed-specific promoters were assembled into a binary vector as previously described and introduced into 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C. sativa 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cv. Celine. Abbreviations: </a:t>
            </a:r>
            <a:r>
              <a:rPr lang="en-US" sz="12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CNL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, </a:t>
            </a:r>
            <a:r>
              <a:rPr lang="en-US" sz="1200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conlinin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 1 promoter for the gene encoding the 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L. </a:t>
            </a:r>
            <a:r>
              <a:rPr lang="en-US" sz="1200" i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usitatissimum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 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2S storage protein </a:t>
            </a:r>
            <a:r>
              <a:rPr lang="en-US" sz="1200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conlinin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; </a:t>
            </a:r>
            <a:r>
              <a:rPr lang="en-US" sz="12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USP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, promoter region of the unknown seed protein of 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V. </a:t>
            </a:r>
            <a:r>
              <a:rPr lang="en-US" sz="1200" i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faba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; </a:t>
            </a:r>
            <a:r>
              <a:rPr lang="en-US" sz="12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SBP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, sucrose binding protein 1800 promoter from 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V. </a:t>
            </a:r>
            <a:r>
              <a:rPr lang="en-US" sz="1200" i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faba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; </a:t>
            </a:r>
            <a:r>
              <a:rPr lang="en-US" sz="12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NP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, </a:t>
            </a:r>
            <a:r>
              <a:rPr lang="en-US" sz="1200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Napin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 seed specific promoter from 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Brassica napus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; </a:t>
            </a:r>
            <a:r>
              <a:rPr lang="en-US" sz="12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CsVMV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, promoter from cassava vein mosaic virus;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 </a:t>
            </a:r>
            <a:r>
              <a:rPr lang="en-US" sz="12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Ot</a:t>
            </a:r>
            <a:r>
              <a:rPr lang="el-GR" sz="12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Δ</a:t>
            </a:r>
            <a:r>
              <a:rPr lang="en-US" sz="12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6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, </a:t>
            </a:r>
            <a:r>
              <a:rPr lang="el-GR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Δ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6-desaturase from 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O. </a:t>
            </a:r>
            <a:r>
              <a:rPr lang="en-US" sz="1200" i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tauri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; </a:t>
            </a:r>
            <a:r>
              <a:rPr lang="en-US" sz="12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PpElo6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, </a:t>
            </a:r>
            <a:r>
              <a:rPr lang="el-GR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Δ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6-elongase from 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P. patens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; </a:t>
            </a:r>
            <a:r>
              <a:rPr lang="en-US" sz="12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Tc</a:t>
            </a:r>
            <a:r>
              <a:rPr lang="el-GR" sz="12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Δ5</a:t>
            </a:r>
            <a:r>
              <a:rPr lang="el-GR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, Δ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5-desaturase from </a:t>
            </a:r>
            <a:r>
              <a:rPr lang="en-US" sz="1200" i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Thraustochytrium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 </a:t>
            </a:r>
            <a:r>
              <a:rPr lang="en-US" sz="1200" i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sp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; </a:t>
            </a:r>
            <a:r>
              <a:rPr lang="en-US" sz="12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Ps</a:t>
            </a:r>
            <a:r>
              <a:rPr lang="el-GR" sz="12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Δ12</a:t>
            </a:r>
            <a:r>
              <a:rPr lang="el-GR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, Δ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12-desaturase from 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P. </a:t>
            </a:r>
            <a:r>
              <a:rPr lang="en-US" sz="1200" i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sojae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; </a:t>
            </a:r>
            <a:r>
              <a:rPr lang="en-US" sz="12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Piw3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, w3-desaturase from 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P. </a:t>
            </a:r>
            <a:r>
              <a:rPr lang="en-US" sz="1200" i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infestans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; </a:t>
            </a:r>
            <a:r>
              <a:rPr lang="en-US" sz="12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OtElo5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, </a:t>
            </a:r>
            <a:r>
              <a:rPr lang="el-GR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Δ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5-elongase from 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O. </a:t>
            </a:r>
            <a:r>
              <a:rPr lang="en-US" sz="1200" i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tauri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; O809Elo5, </a:t>
            </a:r>
            <a:r>
              <a:rPr lang="en-US" sz="12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O809</a:t>
            </a:r>
            <a:r>
              <a:rPr lang="en-US" sz="1200" b="1" dirty="0">
                <a:effectLst/>
                <a:latin typeface="Symbol" panose="05050102010706020507" pitchFamily="18" charset="2"/>
                <a:ea typeface="SimSun" panose="02010600030101010101" pitchFamily="2" charset="-122"/>
                <a:cs typeface="Calibri" panose="020F0502020204030204" pitchFamily="34" charset="0"/>
              </a:rPr>
              <a:t>D</a:t>
            </a:r>
            <a:r>
              <a:rPr lang="en-US" sz="12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4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, </a:t>
            </a:r>
            <a:r>
              <a:rPr lang="el-GR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Δ4-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desaturase from </a:t>
            </a:r>
            <a:r>
              <a:rPr lang="en-US" sz="1200" i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Ostreococcus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 RCC809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; </a:t>
            </a:r>
            <a:r>
              <a:rPr lang="en-US" sz="1200" b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DsRed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, chromophore visual marker from </a:t>
            </a:r>
            <a:r>
              <a:rPr lang="en-US" sz="1200" i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Discosoma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. 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35S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t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,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 </a:t>
            </a:r>
            <a:r>
              <a:rPr lang="en-US" sz="1200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OCS</a:t>
            </a:r>
            <a:r>
              <a:rPr lang="en-US" sz="1200" i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t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,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 </a:t>
            </a:r>
            <a:r>
              <a:rPr lang="en-US" sz="1200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CatpA</a:t>
            </a:r>
            <a:r>
              <a:rPr lang="en-US" sz="1200" i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t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,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 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E9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t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,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 </a:t>
            </a:r>
            <a:r>
              <a:rPr lang="en-US" sz="1200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NOS</a:t>
            </a:r>
            <a:r>
              <a:rPr lang="en-US" sz="1200" i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t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,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 </a:t>
            </a:r>
            <a:r>
              <a:rPr lang="en-US" sz="1200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HSP</a:t>
            </a:r>
            <a:r>
              <a:rPr lang="en-US" sz="1200" i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t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,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 </a:t>
            </a:r>
            <a:r>
              <a:rPr lang="en-US" sz="1200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Phaseolin</a:t>
            </a:r>
            <a:r>
              <a:rPr lang="en-US" sz="1200" i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t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,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 </a:t>
            </a:r>
            <a:r>
              <a:rPr lang="en-US" sz="1200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Gly</a:t>
            </a:r>
            <a:r>
              <a:rPr lang="en-US" sz="1200" i="1" dirty="0" err="1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t</a:t>
            </a:r>
            <a:r>
              <a:rPr lang="en-US" sz="1200" i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 </a:t>
            </a:r>
            <a:r>
              <a:rPr lang="en-US" sz="12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are terminators. The same specific event (#39) was used in this study, as had been used previously (Han et al., 2020).</a:t>
            </a:r>
            <a:endParaRPr lang="en-GB" sz="1200" dirty="0">
              <a:effectLst/>
              <a:latin typeface="Calibri" panose="020F0502020204030204" pitchFamily="34" charset="0"/>
              <a:ea typeface="SimSun" panose="02010600030101010101" pitchFamily="2" charset="-122"/>
              <a:cs typeface="Calibri" panose="020F0502020204030204" pitchFamily="34" charset="0"/>
            </a:endParaRP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009747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665B1C14-7410-4B25-8444-C34F43496822}"/>
              </a:ext>
            </a:extLst>
          </p:cNvPr>
          <p:cNvGrpSpPr/>
          <p:nvPr/>
        </p:nvGrpSpPr>
        <p:grpSpPr>
          <a:xfrm>
            <a:off x="2466100" y="837300"/>
            <a:ext cx="6023559" cy="4074990"/>
            <a:chOff x="3271443" y="1285576"/>
            <a:chExt cx="6847829" cy="4286848"/>
          </a:xfrm>
        </p:grpSpPr>
        <p:pic>
          <p:nvPicPr>
            <p:cNvPr id="4" name="Picture 3" descr="Chart, bar chart&#10;&#10;Description automatically generated">
              <a:extLst>
                <a:ext uri="{FF2B5EF4-FFF2-40B4-BE49-F238E27FC236}">
                  <a16:creationId xmlns:a16="http://schemas.microsoft.com/office/drawing/2014/main" id="{2F41D2F6-F4AE-4F4E-89BE-B9404665B0E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71443" y="1285576"/>
              <a:ext cx="5649113" cy="4286848"/>
            </a:xfrm>
            <a:prstGeom prst="rect">
              <a:avLst/>
            </a:prstGeom>
          </p:spPr>
        </p:pic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2B36B52C-6353-4807-BABA-6D45FB39BDB2}"/>
                </a:ext>
              </a:extLst>
            </p:cNvPr>
            <p:cNvGrpSpPr/>
            <p:nvPr/>
          </p:nvGrpSpPr>
          <p:grpSpPr>
            <a:xfrm>
              <a:off x="8920556" y="2844224"/>
              <a:ext cx="1198716" cy="1169551"/>
              <a:chOff x="8001400" y="3234591"/>
              <a:chExt cx="1198716" cy="1169551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F28A1515-C92E-44DE-95F7-15B6F4A4EC1D}"/>
                  </a:ext>
                </a:extLst>
              </p:cNvPr>
              <p:cNvSpPr txBox="1"/>
              <p:nvPr/>
            </p:nvSpPr>
            <p:spPr>
              <a:xfrm>
                <a:off x="8068075" y="3234591"/>
                <a:ext cx="1132041" cy="1169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300"/>
                  </a:spcAft>
                </a:pP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HA1</a:t>
                </a:r>
              </a:p>
              <a:p>
                <a:pPr>
                  <a:spcAft>
                    <a:spcPts val="300"/>
                  </a:spcAft>
                </a:pP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HA1x</a:t>
                </a:r>
                <a:r>
                  <a:rPr lang="en-GB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fae1</a:t>
                </a:r>
              </a:p>
              <a:p>
                <a:pPr>
                  <a:spcAft>
                    <a:spcPts val="300"/>
                  </a:spcAft>
                </a:pPr>
                <a:r>
                  <a:rPr lang="en-GB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fae1</a:t>
                </a:r>
              </a:p>
              <a:p>
                <a:pPr>
                  <a:spcAft>
                    <a:spcPts val="300"/>
                  </a:spcAft>
                </a:pP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WT(Celine)</a:t>
                </a:r>
              </a:p>
              <a:p>
                <a:pPr>
                  <a:spcAft>
                    <a:spcPts val="300"/>
                  </a:spcAft>
                </a:pP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WT(Suneson)</a:t>
                </a:r>
              </a:p>
            </p:txBody>
          </p:sp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16102A1E-6370-46DA-A6A6-EE6655F48841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8001400" y="4194622"/>
                <a:ext cx="115200" cy="115200"/>
              </a:xfrm>
              <a:prstGeom prst="rect">
                <a:avLst/>
              </a:prstGeom>
              <a:solidFill>
                <a:srgbClr val="FF7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877AD6B2-44E7-4C52-917D-C1482D5A8115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8001400" y="3974283"/>
                <a:ext cx="115200" cy="115200"/>
              </a:xfrm>
              <a:prstGeom prst="rect">
                <a:avLst/>
              </a:prstGeom>
              <a:solidFill>
                <a:srgbClr val="984EA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309C847A-B815-4BBB-BDE6-E51F18CE60C6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8001400" y="3753944"/>
                <a:ext cx="115200" cy="115200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CE0FE54B-87CF-4206-95B9-D6B991C6BA2A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8001400" y="3533605"/>
                <a:ext cx="115200" cy="11520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DFC9122E-1697-4A11-814F-664B6E434A95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8001400" y="3313266"/>
                <a:ext cx="115200" cy="115200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E1FE13B0-CFB8-4F82-A97B-79BFAB268ACB}"/>
              </a:ext>
            </a:extLst>
          </p:cNvPr>
          <p:cNvSpPr txBox="1"/>
          <p:nvPr/>
        </p:nvSpPr>
        <p:spPr>
          <a:xfrm>
            <a:off x="2466100" y="5189703"/>
            <a:ext cx="624979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 S3</a:t>
            </a:r>
            <a:r>
              <a:rPr lang="en-GB" sz="1200" dirty="0"/>
              <a:t>.  Graphical representation of the unsaturation index in the lipids of camelina seeds.  The unsaturation index was calculated according to </a:t>
            </a:r>
            <a:r>
              <a:rPr lang="en-GB" sz="1200" b="0" i="0" dirty="0">
                <a:solidFill>
                  <a:srgbClr val="212121"/>
                </a:solidFill>
                <a:effectLst/>
                <a:latin typeface="BlinkMacSystemFont"/>
              </a:rPr>
              <a:t>Narayanan et al. (2020). Comparative Lipidomic Analysis Reveals Heat Stress Responses of Two Soybean Genotypes Differing in Temperature Sensitivity. </a:t>
            </a:r>
            <a:r>
              <a:rPr lang="en-GB" sz="1200" b="0" i="1" dirty="0">
                <a:solidFill>
                  <a:srgbClr val="212121"/>
                </a:solidFill>
                <a:effectLst/>
                <a:latin typeface="BlinkMacSystemFont"/>
              </a:rPr>
              <a:t>Plants (Basel, Switzerland)</a:t>
            </a:r>
            <a:r>
              <a:rPr lang="en-GB" sz="1200" b="0" i="0" dirty="0">
                <a:solidFill>
                  <a:srgbClr val="212121"/>
                </a:solidFill>
                <a:effectLst/>
                <a:latin typeface="BlinkMacSystemFont"/>
              </a:rPr>
              <a:t>, </a:t>
            </a:r>
            <a:r>
              <a:rPr lang="en-GB" sz="1200" b="0" i="1" dirty="0">
                <a:solidFill>
                  <a:srgbClr val="212121"/>
                </a:solidFill>
                <a:effectLst/>
                <a:latin typeface="BlinkMacSystemFont"/>
              </a:rPr>
              <a:t>9</a:t>
            </a:r>
            <a:r>
              <a:rPr lang="en-GB" sz="1200" b="0" i="0" dirty="0">
                <a:solidFill>
                  <a:srgbClr val="212121"/>
                </a:solidFill>
                <a:effectLst/>
                <a:latin typeface="BlinkMacSystemFont"/>
              </a:rPr>
              <a:t>(4), 457. https://doi.org/10.3390/plants9040457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3307156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>
            <a:extLst>
              <a:ext uri="{FF2B5EF4-FFF2-40B4-BE49-F238E27FC236}">
                <a16:creationId xmlns:a16="http://schemas.microsoft.com/office/drawing/2014/main" id="{DB6EC3D8-8A70-47D5-A1F4-B11D06569784}"/>
              </a:ext>
            </a:extLst>
          </p:cNvPr>
          <p:cNvGrpSpPr/>
          <p:nvPr/>
        </p:nvGrpSpPr>
        <p:grpSpPr>
          <a:xfrm>
            <a:off x="819764" y="363224"/>
            <a:ext cx="10287260" cy="5282568"/>
            <a:chOff x="794597" y="656838"/>
            <a:chExt cx="10602805" cy="5544324"/>
          </a:xfrm>
        </p:grpSpPr>
        <p:pic>
          <p:nvPicPr>
            <p:cNvPr id="3" name="Picture 2" descr="Chart, bar chart&#10;&#10;Description automatically generated">
              <a:extLst>
                <a:ext uri="{FF2B5EF4-FFF2-40B4-BE49-F238E27FC236}">
                  <a16:creationId xmlns:a16="http://schemas.microsoft.com/office/drawing/2014/main" id="{63C69396-3B4C-4344-B95C-5EEC597A921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4597" y="656838"/>
              <a:ext cx="10602805" cy="5544324"/>
            </a:xfrm>
            <a:prstGeom prst="rect">
              <a:avLst/>
            </a:prstGeom>
          </p:spPr>
        </p:pic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5DEBBF62-7546-4A7F-9336-BCA3A93B7317}"/>
                </a:ext>
              </a:extLst>
            </p:cNvPr>
            <p:cNvGrpSpPr/>
            <p:nvPr/>
          </p:nvGrpSpPr>
          <p:grpSpPr>
            <a:xfrm>
              <a:off x="8658625" y="1577241"/>
              <a:ext cx="1198716" cy="1169551"/>
              <a:chOff x="8001400" y="3234591"/>
              <a:chExt cx="1198716" cy="1169551"/>
            </a:xfrm>
          </p:grpSpPr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448792E2-7FC9-4254-BDEF-95A34883A638}"/>
                  </a:ext>
                </a:extLst>
              </p:cNvPr>
              <p:cNvSpPr txBox="1"/>
              <p:nvPr/>
            </p:nvSpPr>
            <p:spPr>
              <a:xfrm>
                <a:off x="8068075" y="3234591"/>
                <a:ext cx="1132041" cy="1169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spcAft>
                    <a:spcPts val="300"/>
                  </a:spcAft>
                </a:pP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HA1</a:t>
                </a:r>
              </a:p>
              <a:p>
                <a:pPr>
                  <a:spcAft>
                    <a:spcPts val="300"/>
                  </a:spcAft>
                </a:pP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HA1x</a:t>
                </a:r>
                <a:r>
                  <a:rPr lang="en-GB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fae1</a:t>
                </a:r>
              </a:p>
              <a:p>
                <a:pPr>
                  <a:spcAft>
                    <a:spcPts val="300"/>
                  </a:spcAft>
                </a:pPr>
                <a:r>
                  <a:rPr lang="en-GB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fae1</a:t>
                </a:r>
              </a:p>
              <a:p>
                <a:pPr>
                  <a:spcAft>
                    <a:spcPts val="300"/>
                  </a:spcAft>
                </a:pP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WT(Celine)</a:t>
                </a:r>
              </a:p>
              <a:p>
                <a:pPr>
                  <a:spcAft>
                    <a:spcPts val="300"/>
                  </a:spcAft>
                </a:pP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WT(Suneson)</a:t>
                </a:r>
              </a:p>
            </p:txBody>
          </p: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EC3551DA-A3AB-4878-8752-2AF3925BC535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8001400" y="4194622"/>
                <a:ext cx="115200" cy="115200"/>
              </a:xfrm>
              <a:prstGeom prst="rect">
                <a:avLst/>
              </a:prstGeom>
              <a:solidFill>
                <a:srgbClr val="FF7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0848362C-0C9E-4CEB-A987-557F27968D87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8001400" y="3974283"/>
                <a:ext cx="115200" cy="115200"/>
              </a:xfrm>
              <a:prstGeom prst="rect">
                <a:avLst/>
              </a:prstGeom>
              <a:solidFill>
                <a:srgbClr val="984EA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52A27A18-7CE2-4776-9933-C6CA6507242E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8001400" y="3753944"/>
                <a:ext cx="115200" cy="115200"/>
              </a:xfrm>
              <a:prstGeom prst="rect">
                <a:avLst/>
              </a:prstGeom>
              <a:solidFill>
                <a:srgbClr val="4DAF4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46DAACE9-EF92-435C-B45F-74C2C843EB86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8001400" y="3533605"/>
                <a:ext cx="115200" cy="11520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215763FE-F329-4D87-8520-DE662CC0AB7E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8001400" y="3313266"/>
                <a:ext cx="115200" cy="115200"/>
              </a:xfrm>
              <a:prstGeom prst="rect">
                <a:avLst/>
              </a:prstGeom>
              <a:solidFill>
                <a:srgbClr val="E41A1C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AA989D15-B263-4AA1-BDF7-0287F67444B9}"/>
              </a:ext>
            </a:extLst>
          </p:cNvPr>
          <p:cNvSpPr txBox="1"/>
          <p:nvPr/>
        </p:nvSpPr>
        <p:spPr>
          <a:xfrm>
            <a:off x="2220286" y="5848445"/>
            <a:ext cx="77514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. S4</a:t>
            </a:r>
            <a:r>
              <a:rPr lang="en-GB" sz="1200" dirty="0"/>
              <a:t>.  TAG profile of different field-grown GM and GE camelina lines. TAG species were separated by </a:t>
            </a:r>
            <a:r>
              <a:rPr lang="en-GB" sz="1200" dirty="0" err="1"/>
              <a:t>uHPLC</a:t>
            </a:r>
            <a:r>
              <a:rPr lang="en-GB" sz="1200" dirty="0"/>
              <a:t> and identified by mass spectrometry as previously described. The presence of the GE </a:t>
            </a:r>
            <a:r>
              <a:rPr lang="en-GB" sz="1200" i="1" dirty="0"/>
              <a:t>fae1</a:t>
            </a:r>
            <a:r>
              <a:rPr lang="en-GB" sz="1200" dirty="0"/>
              <a:t> mutations has a profound impact on the TAG profile, as does the DHA1 transgene activities. </a:t>
            </a:r>
          </a:p>
        </p:txBody>
      </p:sp>
    </p:spTree>
    <p:extLst>
      <p:ext uri="{BB962C8B-B14F-4D97-AF65-F5344CB8AC3E}">
        <p14:creationId xmlns:p14="http://schemas.microsoft.com/office/powerpoint/2010/main" val="12534381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0</TotalTime>
  <Words>484</Words>
  <Application>Microsoft Office PowerPoint</Application>
  <PresentationFormat>Widescreen</PresentationFormat>
  <Paragraphs>1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BlinkMacSystemFont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G graphs</dc:title>
  <dc:creator>Susana Silvestre</dc:creator>
  <cp:lastModifiedBy>Johnathan Napier</cp:lastModifiedBy>
  <cp:revision>14</cp:revision>
  <dcterms:created xsi:type="dcterms:W3CDTF">2022-03-01T23:03:27Z</dcterms:created>
  <dcterms:modified xsi:type="dcterms:W3CDTF">2022-04-08T11:54:21Z</dcterms:modified>
</cp:coreProperties>
</file>